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58"/>
  </p:normalViewPr>
  <p:slideViewPr>
    <p:cSldViewPr snapToGrid="0">
      <p:cViewPr varScale="1">
        <p:scale>
          <a:sx n="105" d="100"/>
          <a:sy n="105" d="100"/>
        </p:scale>
        <p:origin x="79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ACBC7B0-D767-CB20-CFA4-58C3F32F86E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4FA0DFB8-D0B8-FE85-5CB7-D9D9BC16679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C45C5AA-29C0-B5A5-D209-F4E61EE383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574CD-06A9-7743-80B5-0C140B03B0FB}" type="datetimeFigureOut">
              <a:rPr lang="it-IT" smtClean="0"/>
              <a:t>06/11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58EC5E1-9DA9-DBC3-2A20-07C8663DB0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E688278-3F4D-698D-C6A1-71897181A1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E0319-35D8-FF46-AC0B-6FADCD974E4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192649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B65ED0C-50C2-F7EE-A697-26074B8B8D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961E61C0-020A-499F-FE5A-2912878003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198CE02-618C-1B1C-E211-CBF5AD423C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574CD-06A9-7743-80B5-0C140B03B0FB}" type="datetimeFigureOut">
              <a:rPr lang="it-IT" smtClean="0"/>
              <a:t>06/11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B903DA0-EC1B-9D9A-BBAC-F74DB257AE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1E4193F-8336-389F-37DE-FEC9DB9D5C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E0319-35D8-FF46-AC0B-6FADCD974E4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604029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9DD9A065-3883-10CB-BAD8-B7A99734895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52BD5E7A-7F9F-A650-FB9A-E31C6B33E1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6F4E92A-F220-64FB-549F-DC54D06FA6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574CD-06A9-7743-80B5-0C140B03B0FB}" type="datetimeFigureOut">
              <a:rPr lang="it-IT" smtClean="0"/>
              <a:t>06/11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FD0E0BF-7C15-C24B-5AA4-FD7C3FB490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7B15618-DD3E-85C0-9903-CAF19D3180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E0319-35D8-FF46-AC0B-6FADCD974E4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135954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0016EF8-0741-771C-497F-856255684B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F810053-2E89-4A33-0717-6E2FEB32F3C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37D16A5-DB6C-7F13-766A-B8F2E1F3C7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574CD-06A9-7743-80B5-0C140B03B0FB}" type="datetimeFigureOut">
              <a:rPr lang="it-IT" smtClean="0"/>
              <a:t>06/11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4FAB232-DECD-50D8-BB21-AB9CE2C9BE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26C5481-F8F3-8693-CEF6-9C981AD9E9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E0319-35D8-FF46-AC0B-6FADCD974E4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173450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FE337A4-4AC6-3874-A641-450048C14B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537CF96-5721-2111-3EC1-3FAF04F805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875B986-F0F0-08AA-01D6-476F39324F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574CD-06A9-7743-80B5-0C140B03B0FB}" type="datetimeFigureOut">
              <a:rPr lang="it-IT" smtClean="0"/>
              <a:t>06/11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6BE5A84-83E5-C9A2-2A08-36F8A337B4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F9E08F2-40A7-CBA0-371A-CAC15FCF1A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E0319-35D8-FF46-AC0B-6FADCD974E4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491009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A41B499-A18B-F946-6CF7-30426A8EA8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FD265AD-C5F5-7548-CBD6-3909396E840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526814B-7C51-3618-7AA0-09667094F6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7AF6B57-3D0E-C478-50E1-24E0CD909F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574CD-06A9-7743-80B5-0C140B03B0FB}" type="datetimeFigureOut">
              <a:rPr lang="it-IT" smtClean="0"/>
              <a:t>06/11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A8DC90E-DD0A-F40B-FEF7-04EEBB4637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25247AB-B9B9-C6F5-50B0-EFB3D4CEB0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E0319-35D8-FF46-AC0B-6FADCD974E4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775143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61E3EE6-E114-D9ED-D485-CE05DB15A4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DD380BD-E445-C2E3-1E76-62AC4ACC1E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BBB65BAE-82C5-5C5E-8C8D-1CB236A3DB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17794D4F-3807-1128-298F-219E3FDF95D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3D2CFAF8-3F30-3074-BC6D-CDE39AE8580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86474ACA-715E-AAC5-E9DD-5A7AA4CDEF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574CD-06A9-7743-80B5-0C140B03B0FB}" type="datetimeFigureOut">
              <a:rPr lang="it-IT" smtClean="0"/>
              <a:t>06/11/2025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38401B43-AB5D-E260-A9CE-B1BAFC52BC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AC6E5337-D135-CACB-95B3-7DBB3E7ABF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E0319-35D8-FF46-AC0B-6FADCD974E4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341009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74383D1-6665-F9E4-DD23-9711B3BF41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51CA1F27-9FB5-E2C9-5310-F5BE7CFB91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574CD-06A9-7743-80B5-0C140B03B0FB}" type="datetimeFigureOut">
              <a:rPr lang="it-IT" smtClean="0"/>
              <a:t>06/11/2025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87297CD0-5E05-8EC1-BD4F-31D5B0439C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F107440E-0D1A-892D-0DF2-3AB052F353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E0319-35D8-FF46-AC0B-6FADCD974E4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870756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2E39B4B9-223C-086F-48CB-958C13BD00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574CD-06A9-7743-80B5-0C140B03B0FB}" type="datetimeFigureOut">
              <a:rPr lang="it-IT" smtClean="0"/>
              <a:t>06/11/2025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E4A26C0B-6665-7B0F-1AE5-AD76C458A6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AA26B85F-1E87-0D91-4A11-83E5EEFFE9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E0319-35D8-FF46-AC0B-6FADCD974E4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437098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B1EA118-0801-84F2-A9C0-2189B9B36E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ED7A0C57-B36B-5902-9C40-A79FD280E22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F31C97D9-9006-3B44-86D7-A5DA80779D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961BB1B-4A99-7963-4BD9-684A024E15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574CD-06A9-7743-80B5-0C140B03B0FB}" type="datetimeFigureOut">
              <a:rPr lang="it-IT" smtClean="0"/>
              <a:t>06/11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8CCBBE97-B1CA-8279-7EA0-DBBD39C379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B64D341-C1F8-BAA1-EBA8-770EDD58A1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E0319-35D8-FF46-AC0B-6FADCD974E4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542395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56B7D7E-DF2A-72A2-2DE5-CFDE2D4C6F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2368518D-58C4-21C2-D0D8-BF9F684B168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75786A7B-485D-104B-ABF4-D19C4E36B7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05879E0-7C01-9D5C-0A9E-ABB4E3C5D3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574CD-06A9-7743-80B5-0C140B03B0FB}" type="datetimeFigureOut">
              <a:rPr lang="it-IT" smtClean="0"/>
              <a:t>06/11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4D8C787-AD9D-0A81-7447-76395AA9BA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CC55E8E6-C25F-C888-5399-E610C2EA8D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E0319-35D8-FF46-AC0B-6FADCD974E4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629938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2255A8BF-8DC1-99E0-55A4-7A40D3BE07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C1222A1-C81D-966C-86DD-8F80D66E28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14C681E-CD38-F620-7A51-0BA2807AF2A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8E574CD-06A9-7743-80B5-0C140B03B0FB}" type="datetimeFigureOut">
              <a:rPr lang="it-IT" smtClean="0"/>
              <a:t>06/11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764C4F4-EAB7-23A8-5C4D-DA73D9EA372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E27DE7A-5FE4-A071-7FC4-6D7B89C70C9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7FE0319-35D8-FF46-AC0B-6FADCD974E4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300484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FE6B5E44-B2FC-8E81-E5EF-F7981409AF0C}"/>
              </a:ext>
            </a:extLst>
          </p:cNvPr>
          <p:cNvSpPr txBox="1"/>
          <p:nvPr/>
        </p:nvSpPr>
        <p:spPr>
          <a:xfrm>
            <a:off x="2016147" y="85421"/>
            <a:ext cx="815970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600" b="1" dirty="0"/>
              <a:t>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Expression of AQP3 in HT-29 cells treated with </a:t>
            </a:r>
            <a:r>
              <a:rPr lang="en-US" sz="1600" b="1" i="1" dirty="0">
                <a:solidFill>
                  <a:srgbClr val="1B1B1B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Hippophae </a:t>
            </a:r>
            <a:r>
              <a:rPr lang="en-US" sz="1600" b="1" i="1" dirty="0" err="1">
                <a:solidFill>
                  <a:srgbClr val="1B1B1B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hamnoides</a:t>
            </a:r>
            <a:r>
              <a:rPr lang="en-US" sz="1600" b="1" i="1" dirty="0">
                <a:solidFill>
                  <a:srgbClr val="1B1B1B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b="1" dirty="0">
                <a:solidFill>
                  <a:srgbClr val="1B1B1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600" b="1" i="0" dirty="0">
                <a:solidFill>
                  <a:srgbClr val="1B1B1B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xtract </a:t>
            </a:r>
            <a:endParaRPr lang="it-IT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Immagine 6" descr="Immagine che contiene Rettangolo, bianco, bianco e nero, schizzo&#10;&#10;Il contenuto generato dall'IA potrebbe non essere corretto.">
            <a:extLst>
              <a:ext uri="{FF2B5EF4-FFF2-40B4-BE49-F238E27FC236}">
                <a16:creationId xmlns:a16="http://schemas.microsoft.com/office/drawing/2014/main" id="{CB0CE110-ED19-F45B-C26B-E421FE21FEB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0331" y="723167"/>
            <a:ext cx="2742731" cy="2194184"/>
          </a:xfrm>
          <a:prstGeom prst="rect">
            <a:avLst/>
          </a:prstGeom>
        </p:spPr>
      </p:pic>
      <p:pic>
        <p:nvPicPr>
          <p:cNvPr id="9" name="Immagine 8" descr="Immagine che contiene schermata, nero, Rettangolo, bianco e nero&#10;&#10;Il contenuto generato dall'IA potrebbe non essere corretto.">
            <a:extLst>
              <a:ext uri="{FF2B5EF4-FFF2-40B4-BE49-F238E27FC236}">
                <a16:creationId xmlns:a16="http://schemas.microsoft.com/office/drawing/2014/main" id="{5EBFEAE3-CCB3-AD69-8B9F-0A6C0F45390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23167"/>
            <a:ext cx="2742731" cy="2194184"/>
          </a:xfrm>
          <a:prstGeom prst="rect">
            <a:avLst/>
          </a:prstGeom>
        </p:spPr>
      </p:pic>
      <p:pic>
        <p:nvPicPr>
          <p:cNvPr id="11" name="Immagine 10" descr="Immagine che contiene schermata, nero, bianco e nero, Rettangolo&#10;&#10;Il contenuto generato dall'IA potrebbe non essere corretto.">
            <a:extLst>
              <a:ext uri="{FF2B5EF4-FFF2-40B4-BE49-F238E27FC236}">
                <a16:creationId xmlns:a16="http://schemas.microsoft.com/office/drawing/2014/main" id="{78A3A6B2-326C-84A4-5613-ACF39B607F1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80878" y="723167"/>
            <a:ext cx="2742731" cy="2194184"/>
          </a:xfrm>
          <a:prstGeom prst="rect">
            <a:avLst/>
          </a:prstGeom>
        </p:spPr>
      </p:pic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545D02BF-06FC-CE0C-53BB-7735BAFADB63}"/>
              </a:ext>
            </a:extLst>
          </p:cNvPr>
          <p:cNvSpPr txBox="1"/>
          <p:nvPr/>
        </p:nvSpPr>
        <p:spPr>
          <a:xfrm>
            <a:off x="1052052" y="415389"/>
            <a:ext cx="6882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1A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66403A79-06A4-04DF-4613-AF06A6D59B3B}"/>
              </a:ext>
            </a:extLst>
          </p:cNvPr>
          <p:cNvSpPr txBox="1"/>
          <p:nvPr/>
        </p:nvSpPr>
        <p:spPr>
          <a:xfrm>
            <a:off x="3817567" y="415389"/>
            <a:ext cx="6882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1B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50D4B420-F7FB-C836-44CE-442883CA38FE}"/>
              </a:ext>
            </a:extLst>
          </p:cNvPr>
          <p:cNvSpPr txBox="1"/>
          <p:nvPr/>
        </p:nvSpPr>
        <p:spPr>
          <a:xfrm>
            <a:off x="6484058" y="398536"/>
            <a:ext cx="6882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1C</a:t>
            </a:r>
          </a:p>
        </p:txBody>
      </p:sp>
      <p:pic>
        <p:nvPicPr>
          <p:cNvPr id="16" name="Immagine 15" descr="Immagine che contiene schermata, nero, monocromatico, Rettangolo&#10;&#10;Il contenuto generato dall'IA potrebbe non essere corretto.">
            <a:extLst>
              <a:ext uri="{FF2B5EF4-FFF2-40B4-BE49-F238E27FC236}">
                <a16:creationId xmlns:a16="http://schemas.microsoft.com/office/drawing/2014/main" id="{0993E8D0-F03A-9B95-0C10-8599980655B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59" y="3997918"/>
            <a:ext cx="2742730" cy="2194184"/>
          </a:xfrm>
          <a:prstGeom prst="rect">
            <a:avLst/>
          </a:prstGeom>
        </p:spPr>
      </p:pic>
      <p:pic>
        <p:nvPicPr>
          <p:cNvPr id="18" name="Immagine 17" descr="Immagine che contiene schizzo, nero, bianco, bianco e nero&#10;&#10;Il contenuto generato dall'IA potrebbe non essere corretto.">
            <a:extLst>
              <a:ext uri="{FF2B5EF4-FFF2-40B4-BE49-F238E27FC236}">
                <a16:creationId xmlns:a16="http://schemas.microsoft.com/office/drawing/2014/main" id="{FB2A3E7B-EED1-6D3D-A661-AE74D57B09A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6962" y="3997918"/>
            <a:ext cx="2742730" cy="2194184"/>
          </a:xfrm>
          <a:prstGeom prst="rect">
            <a:avLst/>
          </a:prstGeom>
        </p:spPr>
      </p:pic>
      <p:pic>
        <p:nvPicPr>
          <p:cNvPr id="20" name="Immagine 19" descr="Immagine che contiene schermata, nero, Rettangolo, bianco e nero&#10;&#10;Il contenuto generato dall'IA potrebbe non essere corretto.">
            <a:extLst>
              <a:ext uri="{FF2B5EF4-FFF2-40B4-BE49-F238E27FC236}">
                <a16:creationId xmlns:a16="http://schemas.microsoft.com/office/drawing/2014/main" id="{1EE8B1E7-0201-8847-6D5D-905C0DC2135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06458" y="3997918"/>
            <a:ext cx="2742730" cy="2194184"/>
          </a:xfrm>
          <a:prstGeom prst="rect">
            <a:avLst/>
          </a:prstGeom>
        </p:spPr>
      </p:pic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1F8FA3A7-ECF3-B510-9F5F-8E07CDF59D16}"/>
              </a:ext>
            </a:extLst>
          </p:cNvPr>
          <p:cNvSpPr txBox="1"/>
          <p:nvPr/>
        </p:nvSpPr>
        <p:spPr>
          <a:xfrm>
            <a:off x="1056969" y="3743616"/>
            <a:ext cx="6882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2A</a:t>
            </a: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64E0A9F7-6C76-F5E3-7845-DA39570FD8A7}"/>
              </a:ext>
            </a:extLst>
          </p:cNvPr>
          <p:cNvSpPr txBox="1"/>
          <p:nvPr/>
        </p:nvSpPr>
        <p:spPr>
          <a:xfrm>
            <a:off x="3844639" y="3743616"/>
            <a:ext cx="6882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2B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C60442BC-5F27-FF33-F76A-7FB84A9E5C6D}"/>
              </a:ext>
            </a:extLst>
          </p:cNvPr>
          <p:cNvSpPr txBox="1"/>
          <p:nvPr/>
        </p:nvSpPr>
        <p:spPr>
          <a:xfrm>
            <a:off x="6632310" y="3727769"/>
            <a:ext cx="6882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2C</a:t>
            </a: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E496A328-A996-4EB0-341F-7CB15087E24E}"/>
              </a:ext>
            </a:extLst>
          </p:cNvPr>
          <p:cNvSpPr txBox="1"/>
          <p:nvPr/>
        </p:nvSpPr>
        <p:spPr>
          <a:xfrm>
            <a:off x="378048" y="1189307"/>
            <a:ext cx="864597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400" b="1" dirty="0">
                <a:latin typeface="Arial" panose="020B0604020202020204" pitchFamily="34" charset="0"/>
                <a:cs typeface="Arial" panose="020B0604020202020204" pitchFamily="34" charset="0"/>
              </a:rPr>
              <a:t>200kDA</a:t>
            </a:r>
          </a:p>
          <a:p>
            <a:r>
              <a:rPr lang="it-IT" sz="400" b="1" dirty="0">
                <a:latin typeface="Arial" panose="020B0604020202020204" pitchFamily="34" charset="0"/>
                <a:cs typeface="Arial" panose="020B0604020202020204" pitchFamily="34" charset="0"/>
              </a:rPr>
              <a:t>150kDA</a:t>
            </a:r>
          </a:p>
          <a:p>
            <a:endParaRPr lang="it-IT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4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</a:p>
          <a:p>
            <a:r>
              <a:rPr lang="it-IT" sz="400" b="1" dirty="0">
                <a:latin typeface="Arial" panose="020B0604020202020204" pitchFamily="34" charset="0"/>
                <a:cs typeface="Arial" panose="020B0604020202020204" pitchFamily="34" charset="0"/>
              </a:rPr>
              <a:t>75kDA</a:t>
            </a:r>
          </a:p>
          <a:p>
            <a:endParaRPr lang="it-IT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it-IT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it-IT" sz="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400" b="1" dirty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</a:p>
          <a:p>
            <a:endParaRPr lang="it-IT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it-IT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400" b="1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</a:p>
          <a:p>
            <a:endParaRPr lang="it-IT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it-IT" sz="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400" b="1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</a:p>
        </p:txBody>
      </p:sp>
      <p:sp>
        <p:nvSpPr>
          <p:cNvPr id="34" name="CasellaDiTesto 33">
            <a:extLst>
              <a:ext uri="{FF2B5EF4-FFF2-40B4-BE49-F238E27FC236}">
                <a16:creationId xmlns:a16="http://schemas.microsoft.com/office/drawing/2014/main" id="{E1E237DD-BCBD-9CB0-F0D0-D23F94A2AFFA}"/>
              </a:ext>
            </a:extLst>
          </p:cNvPr>
          <p:cNvSpPr txBox="1"/>
          <p:nvPr/>
        </p:nvSpPr>
        <p:spPr>
          <a:xfrm>
            <a:off x="5963590" y="1179147"/>
            <a:ext cx="864597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400" b="1" dirty="0">
                <a:latin typeface="Arial" panose="020B0604020202020204" pitchFamily="34" charset="0"/>
                <a:cs typeface="Arial" panose="020B0604020202020204" pitchFamily="34" charset="0"/>
              </a:rPr>
              <a:t>200kDA</a:t>
            </a:r>
          </a:p>
          <a:p>
            <a:r>
              <a:rPr lang="it-IT" sz="400" b="1" dirty="0">
                <a:latin typeface="Arial" panose="020B0604020202020204" pitchFamily="34" charset="0"/>
                <a:cs typeface="Arial" panose="020B0604020202020204" pitchFamily="34" charset="0"/>
              </a:rPr>
              <a:t>150kDA</a:t>
            </a:r>
          </a:p>
          <a:p>
            <a:endParaRPr lang="it-IT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4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</a:p>
          <a:p>
            <a:r>
              <a:rPr lang="it-IT" sz="400" b="1" dirty="0">
                <a:latin typeface="Arial" panose="020B0604020202020204" pitchFamily="34" charset="0"/>
                <a:cs typeface="Arial" panose="020B0604020202020204" pitchFamily="34" charset="0"/>
              </a:rPr>
              <a:t>75kDA</a:t>
            </a:r>
          </a:p>
          <a:p>
            <a:endParaRPr lang="it-IT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it-IT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it-IT" sz="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400" b="1" dirty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</a:p>
          <a:p>
            <a:endParaRPr lang="it-IT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it-IT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400" b="1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</a:p>
          <a:p>
            <a:endParaRPr lang="it-IT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it-IT" sz="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400" b="1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</a:p>
        </p:txBody>
      </p:sp>
      <p:sp>
        <p:nvSpPr>
          <p:cNvPr id="35" name="CasellaDiTesto 34">
            <a:extLst>
              <a:ext uri="{FF2B5EF4-FFF2-40B4-BE49-F238E27FC236}">
                <a16:creationId xmlns:a16="http://schemas.microsoft.com/office/drawing/2014/main" id="{85B91C59-E0E3-A990-BB76-7496AD4C4F11}"/>
              </a:ext>
            </a:extLst>
          </p:cNvPr>
          <p:cNvSpPr txBox="1"/>
          <p:nvPr/>
        </p:nvSpPr>
        <p:spPr>
          <a:xfrm>
            <a:off x="746655" y="4640312"/>
            <a:ext cx="864597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400" b="1" dirty="0">
                <a:latin typeface="Arial" panose="020B0604020202020204" pitchFamily="34" charset="0"/>
                <a:cs typeface="Arial" panose="020B0604020202020204" pitchFamily="34" charset="0"/>
              </a:rPr>
              <a:t>200kDA</a:t>
            </a:r>
          </a:p>
          <a:p>
            <a:r>
              <a:rPr lang="it-IT" sz="400" b="1" dirty="0">
                <a:latin typeface="Arial" panose="020B0604020202020204" pitchFamily="34" charset="0"/>
                <a:cs typeface="Arial" panose="020B0604020202020204" pitchFamily="34" charset="0"/>
              </a:rPr>
              <a:t>150kDA</a:t>
            </a:r>
          </a:p>
          <a:p>
            <a:endParaRPr lang="it-IT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4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</a:p>
          <a:p>
            <a:r>
              <a:rPr lang="it-IT" sz="400" b="1" dirty="0">
                <a:latin typeface="Arial" panose="020B0604020202020204" pitchFamily="34" charset="0"/>
                <a:cs typeface="Arial" panose="020B0604020202020204" pitchFamily="34" charset="0"/>
              </a:rPr>
              <a:t>75kDA</a:t>
            </a:r>
          </a:p>
          <a:p>
            <a:endParaRPr lang="it-IT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it-IT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it-IT" sz="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400" b="1" dirty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</a:p>
          <a:p>
            <a:endParaRPr lang="it-IT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it-IT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400" b="1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</a:p>
          <a:p>
            <a:endParaRPr lang="it-IT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it-IT" sz="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400" b="1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</a:p>
        </p:txBody>
      </p:sp>
      <p:sp>
        <p:nvSpPr>
          <p:cNvPr id="36" name="CasellaDiTesto 35">
            <a:extLst>
              <a:ext uri="{FF2B5EF4-FFF2-40B4-BE49-F238E27FC236}">
                <a16:creationId xmlns:a16="http://schemas.microsoft.com/office/drawing/2014/main" id="{794F3AF5-D202-FB05-6FF5-9C1290027FC1}"/>
              </a:ext>
            </a:extLst>
          </p:cNvPr>
          <p:cNvSpPr txBox="1"/>
          <p:nvPr/>
        </p:nvSpPr>
        <p:spPr>
          <a:xfrm>
            <a:off x="6341723" y="4635810"/>
            <a:ext cx="864597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400" b="1" dirty="0">
                <a:latin typeface="Arial" panose="020B0604020202020204" pitchFamily="34" charset="0"/>
                <a:cs typeface="Arial" panose="020B0604020202020204" pitchFamily="34" charset="0"/>
              </a:rPr>
              <a:t>200kDA</a:t>
            </a:r>
          </a:p>
          <a:p>
            <a:r>
              <a:rPr lang="it-IT" sz="400" b="1" dirty="0">
                <a:latin typeface="Arial" panose="020B0604020202020204" pitchFamily="34" charset="0"/>
                <a:cs typeface="Arial" panose="020B0604020202020204" pitchFamily="34" charset="0"/>
              </a:rPr>
              <a:t>150kDA</a:t>
            </a:r>
          </a:p>
          <a:p>
            <a:endParaRPr lang="it-IT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4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</a:p>
          <a:p>
            <a:r>
              <a:rPr lang="it-IT" sz="400" b="1" dirty="0">
                <a:latin typeface="Arial" panose="020B0604020202020204" pitchFamily="34" charset="0"/>
                <a:cs typeface="Arial" panose="020B0604020202020204" pitchFamily="34" charset="0"/>
              </a:rPr>
              <a:t>75kDA</a:t>
            </a:r>
          </a:p>
          <a:p>
            <a:endParaRPr lang="it-IT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it-IT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it-IT" sz="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400" b="1" dirty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</a:p>
          <a:p>
            <a:endParaRPr lang="it-IT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it-IT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400" b="1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</a:p>
          <a:p>
            <a:endParaRPr lang="it-IT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it-IT" sz="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400" b="1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</a:p>
        </p:txBody>
      </p:sp>
      <p:sp>
        <p:nvSpPr>
          <p:cNvPr id="37" name="Rettangolo 36">
            <a:extLst>
              <a:ext uri="{FF2B5EF4-FFF2-40B4-BE49-F238E27FC236}">
                <a16:creationId xmlns:a16="http://schemas.microsoft.com/office/drawing/2014/main" id="{0EAC89CE-0D16-4A66-19DE-E293216DFE92}"/>
              </a:ext>
            </a:extLst>
          </p:cNvPr>
          <p:cNvSpPr/>
          <p:nvPr/>
        </p:nvSpPr>
        <p:spPr>
          <a:xfrm>
            <a:off x="3362632" y="1965960"/>
            <a:ext cx="1297858" cy="11239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8" name="Rettangolo 37">
            <a:extLst>
              <a:ext uri="{FF2B5EF4-FFF2-40B4-BE49-F238E27FC236}">
                <a16:creationId xmlns:a16="http://schemas.microsoft.com/office/drawing/2014/main" id="{DF6729D4-5C26-0B1C-1783-0712DF8ECC55}"/>
              </a:ext>
            </a:extLst>
          </p:cNvPr>
          <p:cNvSpPr/>
          <p:nvPr/>
        </p:nvSpPr>
        <p:spPr>
          <a:xfrm>
            <a:off x="3774021" y="5065550"/>
            <a:ext cx="1297858" cy="11239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1" name="CasellaDiTesto 40">
            <a:extLst>
              <a:ext uri="{FF2B5EF4-FFF2-40B4-BE49-F238E27FC236}">
                <a16:creationId xmlns:a16="http://schemas.microsoft.com/office/drawing/2014/main" id="{C1EBEA24-D5C2-DB73-F9AC-41D97CD2EC79}"/>
              </a:ext>
            </a:extLst>
          </p:cNvPr>
          <p:cNvSpPr txBox="1"/>
          <p:nvPr/>
        </p:nvSpPr>
        <p:spPr>
          <a:xfrm>
            <a:off x="-42676" y="2917351"/>
            <a:ext cx="7530936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Original blot image of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QP3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it-IT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Abcam</a:t>
            </a:r>
            <a:r>
              <a:rPr lang="it-IT" sz="1100" i="1" dirty="0">
                <a:latin typeface="Arial" panose="020B0604020202020204" pitchFamily="34" charset="0"/>
                <a:cs typeface="Arial" panose="020B0604020202020204" pitchFamily="34" charset="0"/>
              </a:rPr>
              <a:t>, ab125219, 1:1000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rotein expression following 24 hours of treatment with Hippophae rhamnoides extract (2,1–210 ug/ml) or vehicle (10/90 methanol/water).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(Figure S1A) Colorimetric; (Figure S1B) Chemiluminescence; (Figure S1C) Merge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Yellow boxes indicate the regions used for signal quantification.</a:t>
            </a:r>
            <a:endParaRPr lang="it-IT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it-IT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</a:p>
        </p:txBody>
      </p:sp>
      <p:sp>
        <p:nvSpPr>
          <p:cNvPr id="43" name="CasellaDiTesto 42">
            <a:extLst>
              <a:ext uri="{FF2B5EF4-FFF2-40B4-BE49-F238E27FC236}">
                <a16:creationId xmlns:a16="http://schemas.microsoft.com/office/drawing/2014/main" id="{E2A6D29C-593D-EDCA-32CB-0C363F9AD616}"/>
              </a:ext>
            </a:extLst>
          </p:cNvPr>
          <p:cNvSpPr txBox="1"/>
          <p:nvPr/>
        </p:nvSpPr>
        <p:spPr>
          <a:xfrm>
            <a:off x="-42677" y="6192102"/>
            <a:ext cx="8516888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Original blot image of </a:t>
            </a:r>
            <a:r>
              <a:rPr lang="el-GR" sz="1100" b="1" dirty="0"/>
              <a:t>α</a:t>
            </a:r>
            <a:r>
              <a:rPr lang="it-IT" sz="1100" b="1" dirty="0"/>
              <a:t>-</a:t>
            </a:r>
            <a:r>
              <a:rPr lang="it-IT" sz="1100" b="1" dirty="0" err="1"/>
              <a:t>tubulin</a:t>
            </a:r>
            <a:r>
              <a:rPr lang="it-IT" sz="1100" b="1" dirty="0"/>
              <a:t> 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it-IT" sz="1100" i="1" dirty="0">
                <a:latin typeface="Arial" panose="020B0604020202020204" pitchFamily="34" charset="0"/>
                <a:cs typeface="Arial" panose="020B0604020202020204" pitchFamily="34" charset="0"/>
              </a:rPr>
              <a:t>Proteintech, 11224-1-AP, 1:2000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) protein expression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ollowing 24 hours of treatment with Hippophae rhamnoides extract (2,1–210 ug/ml) or vehicle (10/90 methanol/water)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. (Figure S2A) Colorimetric; (Figure S2B) Chemiluminescence; (</a:t>
            </a:r>
            <a:r>
              <a:rPr lang="it-IT" sz="1100">
                <a:latin typeface="Arial" panose="020B0604020202020204" pitchFamily="34" charset="0"/>
                <a:cs typeface="Arial" panose="020B0604020202020204" pitchFamily="34" charset="0"/>
              </a:rPr>
              <a:t>Figure S2C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) Merge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Yellow boxes indicate the regions used for signal quantification.</a:t>
            </a:r>
            <a:endParaRPr lang="it-IT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it-IT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</a:p>
        </p:txBody>
      </p:sp>
    </p:spTree>
    <p:extLst>
      <p:ext uri="{BB962C8B-B14F-4D97-AF65-F5344CB8AC3E}">
        <p14:creationId xmlns:p14="http://schemas.microsoft.com/office/powerpoint/2010/main" val="150564000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84</Words>
  <Application>Microsoft Office PowerPoint</Application>
  <PresentationFormat>Widescreen</PresentationFormat>
  <Paragraphs>7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ema di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 Vittoria Morone</dc:creator>
  <cp:lastModifiedBy>MDPI</cp:lastModifiedBy>
  <cp:revision>2</cp:revision>
  <dcterms:created xsi:type="dcterms:W3CDTF">2025-10-21T08:32:36Z</dcterms:created>
  <dcterms:modified xsi:type="dcterms:W3CDTF">2025-11-06T04:26:07Z</dcterms:modified>
</cp:coreProperties>
</file>